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notesMasterIdLst>
    <p:notesMasterId r:id="rId3"/>
  </p:notes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ECFF"/>
    <a:srgbClr val="FFCC99"/>
    <a:srgbClr val="FF99FF"/>
    <a:srgbClr val="99FF99"/>
    <a:srgbClr val="FFFF99"/>
    <a:srgbClr val="CCFF99"/>
    <a:srgbClr val="FFFF66"/>
    <a:srgbClr val="9966FF"/>
    <a:srgbClr val="6699FF"/>
    <a:srgbClr val="66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-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37DD93-D61D-4909-A638-DA3C83AABEA2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53AF62-67FE-4394-B955-1B138A27CC7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38201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53AF62-67FE-4394-B955-1B138A27CC7B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670828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0325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8401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831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058466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9710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995999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37988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000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1051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7985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2975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DA30F-8A7B-4105-9812-FE9C216B3FA6}" type="datetimeFigureOut">
              <a:rPr lang="es-ES" smtClean="0"/>
              <a:t>20/08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68B20B-977E-4210-AAD5-4AF40CF937E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6495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6" name="Grupo 45">
            <a:extLst>
              <a:ext uri="{FF2B5EF4-FFF2-40B4-BE49-F238E27FC236}">
                <a16:creationId xmlns:a16="http://schemas.microsoft.com/office/drawing/2014/main" id="{9B4D06F2-50AA-9C95-CA9B-8EB4CBE2100C}"/>
              </a:ext>
            </a:extLst>
          </p:cNvPr>
          <p:cNvGrpSpPr/>
          <p:nvPr/>
        </p:nvGrpSpPr>
        <p:grpSpPr>
          <a:xfrm>
            <a:off x="1482150" y="1009215"/>
            <a:ext cx="3893700" cy="7701765"/>
            <a:chOff x="1352779" y="384053"/>
            <a:chExt cx="3893700" cy="7701765"/>
          </a:xfrm>
        </p:grpSpPr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1D7C9374-FF62-41DE-B986-13A28BA2D73C}"/>
                </a:ext>
              </a:extLst>
            </p:cNvPr>
            <p:cNvSpPr txBox="1"/>
            <p:nvPr/>
          </p:nvSpPr>
          <p:spPr>
            <a:xfrm>
              <a:off x="1352779" y="384053"/>
              <a:ext cx="4435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pic>
          <p:nvPicPr>
            <p:cNvPr id="22" name="Imagen 21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E327304E-20E3-7735-1D2F-CE52ADADC5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5084" y="680167"/>
              <a:ext cx="1792405" cy="1800000"/>
            </a:xfrm>
            <a:prstGeom prst="rect">
              <a:avLst/>
            </a:prstGeom>
          </p:spPr>
        </p:pic>
        <p:pic>
          <p:nvPicPr>
            <p:cNvPr id="24" name="Imagen 23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DCBBA9DB-4325-88F3-1363-D4597818F0A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48464" y="680167"/>
              <a:ext cx="1792405" cy="1800000"/>
            </a:xfrm>
            <a:prstGeom prst="rect">
              <a:avLst/>
            </a:prstGeom>
          </p:spPr>
        </p:pic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39CB177D-B31A-7D8A-9492-98A9F382DC75}"/>
                </a:ext>
              </a:extLst>
            </p:cNvPr>
            <p:cNvSpPr txBox="1"/>
            <p:nvPr/>
          </p:nvSpPr>
          <p:spPr>
            <a:xfrm>
              <a:off x="1587911" y="401470"/>
              <a:ext cx="8940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pox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hort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CuadroTexto 31">
              <a:extLst>
                <a:ext uri="{FF2B5EF4-FFF2-40B4-BE49-F238E27FC236}">
                  <a16:creationId xmlns:a16="http://schemas.microsoft.com/office/drawing/2014/main" id="{BBAD8324-C192-D5A9-6C77-9697DC4413E3}"/>
                </a:ext>
              </a:extLst>
            </p:cNvPr>
            <p:cNvSpPr txBox="1"/>
            <p:nvPr/>
          </p:nvSpPr>
          <p:spPr>
            <a:xfrm>
              <a:off x="3329616" y="384053"/>
              <a:ext cx="4435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3" name="CuadroTexto 32">
              <a:extLst>
                <a:ext uri="{FF2B5EF4-FFF2-40B4-BE49-F238E27FC236}">
                  <a16:creationId xmlns:a16="http://schemas.microsoft.com/office/drawing/2014/main" id="{666FA865-E65F-EC8A-1BC9-A69A1510B212}"/>
                </a:ext>
              </a:extLst>
            </p:cNvPr>
            <p:cNvSpPr txBox="1"/>
            <p:nvPr/>
          </p:nvSpPr>
          <p:spPr>
            <a:xfrm>
              <a:off x="3564748" y="401470"/>
              <a:ext cx="8940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Mpox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cohort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Imagen 34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02667BA2-9606-23DD-108A-A23249BE45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4074" y="2539371"/>
              <a:ext cx="1792405" cy="1800000"/>
            </a:xfrm>
            <a:prstGeom prst="rect">
              <a:avLst/>
            </a:prstGeom>
          </p:spPr>
        </p:pic>
        <p:pic>
          <p:nvPicPr>
            <p:cNvPr id="37" name="Imagen 36" descr="Gráfico&#10;&#10;El contenido generado por IA puede ser incorrecto.">
              <a:extLst>
                <a:ext uri="{FF2B5EF4-FFF2-40B4-BE49-F238E27FC236}">
                  <a16:creationId xmlns:a16="http://schemas.microsoft.com/office/drawing/2014/main" id="{2AE03BCF-EE8D-A6CD-934A-00E7EFD4402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5084" y="2539371"/>
              <a:ext cx="1792405" cy="1800000"/>
            </a:xfrm>
            <a:prstGeom prst="rect">
              <a:avLst/>
            </a:prstGeom>
          </p:spPr>
        </p:pic>
        <p:pic>
          <p:nvPicPr>
            <p:cNvPr id="39" name="Imagen 38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9C8B5688-A26A-F287-83FD-22092AE9505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6117" y="4418038"/>
              <a:ext cx="1790886" cy="1800000"/>
            </a:xfrm>
            <a:prstGeom prst="rect">
              <a:avLst/>
            </a:prstGeom>
          </p:spPr>
        </p:pic>
        <p:pic>
          <p:nvPicPr>
            <p:cNvPr id="41" name="Imagen 40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64689818-9D41-129F-C2F9-DA263CE219E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54074" y="4418038"/>
              <a:ext cx="1792405" cy="1800000"/>
            </a:xfrm>
            <a:prstGeom prst="rect">
              <a:avLst/>
            </a:prstGeom>
          </p:spPr>
        </p:pic>
        <p:pic>
          <p:nvPicPr>
            <p:cNvPr id="43" name="Imagen 42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A622A56E-D96A-E13C-DEFC-CA722484B26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8884" y="6282544"/>
              <a:ext cx="1792405" cy="1800000"/>
            </a:xfrm>
            <a:prstGeom prst="rect">
              <a:avLst/>
            </a:prstGeom>
          </p:spPr>
        </p:pic>
        <p:pic>
          <p:nvPicPr>
            <p:cNvPr id="45" name="Imagen 44" descr="Gráfico, Gráfico de dispersión&#10;&#10;El contenido generado por IA puede ser incorrecto.">
              <a:extLst>
                <a:ext uri="{FF2B5EF4-FFF2-40B4-BE49-F238E27FC236}">
                  <a16:creationId xmlns:a16="http://schemas.microsoft.com/office/drawing/2014/main" id="{1B0A9FFC-089E-3DB9-050D-7F326886A4A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84627" y="6285818"/>
              <a:ext cx="1792405" cy="1800000"/>
            </a:xfrm>
            <a:prstGeom prst="rect">
              <a:avLst/>
            </a:prstGeom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91BA483B-E92B-0B4C-E058-99CDF73C2EAF}"/>
              </a:ext>
            </a:extLst>
          </p:cNvPr>
          <p:cNvSpPr txBox="1"/>
          <p:nvPr/>
        </p:nvSpPr>
        <p:spPr>
          <a:xfrm>
            <a:off x="378120" y="115682"/>
            <a:ext cx="62369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arman correlation between the levels of pSAMHD1 and viral replication (p24-gag) in the cohorts of participants without (A) or with (B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pox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vious infection. Spearman correlation coefficient r and p-values were calculated using a combination of Python libraries. Regression plots were generated using the Seaborn library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2871736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6</TotalTime>
  <Words>66</Words>
  <Application>Microsoft Office PowerPoint</Application>
  <PresentationFormat>Presentación en pantalla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sado Fernández Guiomar</dc:creator>
  <cp:lastModifiedBy>Monserrat Torres Hortal</cp:lastModifiedBy>
  <cp:revision>89</cp:revision>
  <cp:lastPrinted>2025-02-27T09:45:56Z</cp:lastPrinted>
  <dcterms:created xsi:type="dcterms:W3CDTF">2022-01-10T11:03:11Z</dcterms:created>
  <dcterms:modified xsi:type="dcterms:W3CDTF">2025-08-20T13:27:27Z</dcterms:modified>
</cp:coreProperties>
</file>